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aveSubsetFonts="1">
  <p:sldMasterIdLst>
    <p:sldMasterId id="2147483693" r:id="rId1"/>
  </p:sldMasterIdLst>
  <p:notesMasterIdLst>
    <p:notesMasterId r:id="rId3"/>
  </p:notesMasterIdLst>
  <p:sldIdLst>
    <p:sldId id="277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5" userDrawn="1">
          <p15:clr>
            <a:srgbClr val="A4A3A4"/>
          </p15:clr>
        </p15:guide>
        <p15:guide id="2" pos="3980" userDrawn="1">
          <p15:clr>
            <a:srgbClr val="A4A3A4"/>
          </p15:clr>
        </p15:guide>
        <p15:guide id="3" orient="horz" pos="136" userDrawn="1">
          <p15:clr>
            <a:srgbClr val="A4A3A4"/>
          </p15:clr>
        </p15:guide>
        <p15:guide id="4" orient="horz" pos="430" userDrawn="1">
          <p15:clr>
            <a:srgbClr val="A4A3A4"/>
          </p15:clr>
        </p15:guide>
        <p15:guide id="5" pos="2531" userDrawn="1">
          <p15:clr>
            <a:srgbClr val="A4A3A4"/>
          </p15:clr>
        </p15:guide>
        <p15:guide id="6" pos="4081" userDrawn="1">
          <p15:clr>
            <a:srgbClr val="A4A3A4"/>
          </p15:clr>
        </p15:guide>
        <p15:guide id="7" pos="2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B7F8D"/>
    <a:srgbClr val="3294A5"/>
    <a:srgbClr val="EBD9D4"/>
    <a:srgbClr val="FFFF00"/>
    <a:srgbClr val="00ACAC"/>
    <a:srgbClr val="8DDADA"/>
    <a:srgbClr val="FF7F00"/>
    <a:srgbClr val="FFFFFF"/>
    <a:srgbClr val="00D400"/>
    <a:srgbClr val="0A0A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81"/>
  </p:normalViewPr>
  <p:slideViewPr>
    <p:cSldViewPr snapToGrid="0">
      <p:cViewPr varScale="1">
        <p:scale>
          <a:sx n="76" d="100"/>
          <a:sy n="76" d="100"/>
        </p:scale>
        <p:origin x="2960" y="200"/>
      </p:cViewPr>
      <p:guideLst>
        <p:guide orient="horz" pos="325"/>
        <p:guide pos="3980"/>
        <p:guide orient="horz" pos="136"/>
        <p:guide orient="horz" pos="430"/>
        <p:guide pos="2531"/>
        <p:guide pos="4081"/>
        <p:guide pos="22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AF9105-D00B-4DC7-9AB0-30C33FCF1B3A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2988" y="1143000"/>
            <a:ext cx="2232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F16437-7826-4920-ACC6-4172DF0348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96366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1pPr>
    <a:lvl2pPr marL="321938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2pPr>
    <a:lvl3pPr marL="643878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3pPr>
    <a:lvl4pPr marL="965817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4pPr>
    <a:lvl5pPr marL="1287757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5pPr>
    <a:lvl6pPr marL="1609696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6pPr>
    <a:lvl7pPr marL="1931635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7pPr>
    <a:lvl8pPr marL="2253573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8pPr>
    <a:lvl9pPr marL="2575513" algn="l" defTabSz="643878" rtl="0" eaLnBrk="1" latinLnBrk="0" hangingPunct="1">
      <a:defRPr sz="84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602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964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09823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upp Fi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C0383-2152-D1B8-D84B-766322BA301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60468" y="695961"/>
            <a:ext cx="766496" cy="1230233"/>
          </a:xfrm>
        </p:spPr>
        <p:txBody>
          <a:bodyPr anchor="t" anchorCtr="0">
            <a:normAutofit/>
          </a:bodyPr>
          <a:lstStyle>
            <a:lvl1pPr>
              <a:defRPr sz="3136"/>
            </a:lvl1pPr>
          </a:lstStyle>
          <a:p>
            <a:r>
              <a:rPr lang="en-US"/>
              <a:t>Supp Fig</a:t>
            </a:r>
            <a:endParaRPr lang="en-GB"/>
          </a:p>
        </p:txBody>
      </p:sp>
      <p:sp>
        <p:nvSpPr>
          <p:cNvPr id="11" name="Text Placeholder 10">
            <a:extLst>
              <a:ext uri="{FF2B5EF4-FFF2-40B4-BE49-F238E27FC236}">
                <a16:creationId xmlns:a16="http://schemas.microsoft.com/office/drawing/2014/main" id="{746AA06D-CC6E-6684-8727-D88770E91E4C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1178418" y="695960"/>
            <a:ext cx="2601420" cy="1230013"/>
          </a:xfrm>
        </p:spPr>
        <p:txBody>
          <a:bodyPr/>
          <a:lstStyle>
            <a:lvl1pPr marL="0" indent="0">
              <a:buNone/>
              <a:defRPr lang="en-US" sz="3136" kern="1200" dirty="0" smtClean="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17A9DA46-C66C-AD71-A262-124A2AEFD5EA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160448" y="2000885"/>
            <a:ext cx="3619390" cy="7742555"/>
          </a:xfrm>
        </p:spPr>
        <p:txBody>
          <a:bodyPr>
            <a:normAutofit/>
          </a:bodyPr>
          <a:lstStyle>
            <a:lvl1pPr>
              <a:defRPr sz="2613"/>
            </a:lvl1pPr>
            <a:lvl2pPr>
              <a:defRPr sz="2352"/>
            </a:lvl2pPr>
            <a:lvl3pPr>
              <a:defRPr sz="2091"/>
            </a:lvl3pPr>
            <a:lvl4pPr>
              <a:defRPr sz="1829"/>
            </a:lvl4pPr>
            <a:lvl5pPr>
              <a:defRPr sz="1829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15" name="Footer Placeholder 14">
            <a:extLst>
              <a:ext uri="{FF2B5EF4-FFF2-40B4-BE49-F238E27FC236}">
                <a16:creationId xmlns:a16="http://schemas.microsoft.com/office/drawing/2014/main" id="{2B8D20A0-4C68-485D-03C4-81273115C7F8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>
          <a:xfrm>
            <a:off x="841548" y="530297"/>
            <a:ext cx="674971" cy="806429"/>
          </a:xfrm>
        </p:spPr>
        <p:txBody>
          <a:bodyPr/>
          <a:lstStyle>
            <a:lvl1pPr algn="l">
              <a:defRPr sz="3136">
                <a:solidFill>
                  <a:schemeClr val="tx1"/>
                </a:solidFill>
              </a:defRPr>
            </a:lvl1pPr>
          </a:lstStyle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875504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288">
          <p15:clr>
            <a:srgbClr val="FBAE40"/>
          </p15:clr>
        </p15:guide>
        <p15:guide id="2" pos="238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5238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4215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259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0538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680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4587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602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725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F920EB-1F3C-473C-9BBF-014D00AFA478}" type="datetimeFigureOut">
              <a:rPr lang="en-GB" smtClean="0"/>
              <a:t>1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5CB910-FF12-435D-A687-ABC2FFC870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905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  <p:sldLayoutId id="2147483706" r:id="rId12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3288" userDrawn="1">
          <p15:clr>
            <a:srgbClr val="F26B43"/>
          </p15:clr>
        </p15:guide>
        <p15:guide id="2" pos="2381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B13D937-5949-233C-EF43-12A9E5DA87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B1A6A42-F198-5E8C-2E9C-9CDDBE1EEE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9113594"/>
              </p:ext>
            </p:extLst>
          </p:nvPr>
        </p:nvGraphicFramePr>
        <p:xfrm>
          <a:off x="349250" y="-36513"/>
          <a:ext cx="6524625" cy="47879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191453" imgH="4543343" progId="Prism10.Document">
                  <p:embed/>
                </p:oleObj>
              </mc:Choice>
              <mc:Fallback>
                <p:oleObj name="Prism 10" r:id="rId2" imgW="6191453" imgH="454334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B1A6A42-F198-5E8C-2E9C-9CDDBE1EEE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9250" y="-36513"/>
                        <a:ext cx="6524625" cy="47879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8" name="Picture 47" descr="A collage of images of different colors&#10;&#10;Description automatically generated">
            <a:extLst>
              <a:ext uri="{FF2B5EF4-FFF2-40B4-BE49-F238E27FC236}">
                <a16:creationId xmlns:a16="http://schemas.microsoft.com/office/drawing/2014/main" id="{DA0E1E70-4085-B2A1-1A2A-8E585DB3CE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34" t="49400"/>
          <a:stretch>
            <a:fillRect/>
          </a:stretch>
        </p:blipFill>
        <p:spPr>
          <a:xfrm>
            <a:off x="838458" y="6798292"/>
            <a:ext cx="6301878" cy="1952599"/>
          </a:xfrm>
          <a:prstGeom prst="rect">
            <a:avLst/>
          </a:prstGeom>
        </p:spPr>
      </p:pic>
      <p:pic>
        <p:nvPicPr>
          <p:cNvPr id="3" name="Picture 2" descr="A collage of images of different colors&#10;&#10;Description automatically generated">
            <a:extLst>
              <a:ext uri="{FF2B5EF4-FFF2-40B4-BE49-F238E27FC236}">
                <a16:creationId xmlns:a16="http://schemas.microsoft.com/office/drawing/2014/main" id="{31225DA1-9183-85E4-0595-46A386506FC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34" b="58024"/>
          <a:stretch>
            <a:fillRect/>
          </a:stretch>
        </p:blipFill>
        <p:spPr>
          <a:xfrm>
            <a:off x="856172" y="5020380"/>
            <a:ext cx="6301878" cy="1619805"/>
          </a:xfrm>
          <a:prstGeom prst="rect">
            <a:avLst/>
          </a:prstGeom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15D0E660-FF8A-5CA7-27C9-76230D330127}"/>
              </a:ext>
            </a:extLst>
          </p:cNvPr>
          <p:cNvSpPr/>
          <p:nvPr/>
        </p:nvSpPr>
        <p:spPr>
          <a:xfrm>
            <a:off x="1131926" y="8270702"/>
            <a:ext cx="6085367" cy="3549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59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67D1F2D-4519-0E04-9245-456F80BC8CF0}"/>
              </a:ext>
            </a:extLst>
          </p:cNvPr>
          <p:cNvSpPr txBox="1"/>
          <p:nvPr/>
        </p:nvSpPr>
        <p:spPr>
          <a:xfrm>
            <a:off x="747144" y="4899336"/>
            <a:ext cx="2056739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GB" sz="1159" b="1">
                <a:latin typeface="Arial" panose="020B0604020202020204" pitchFamily="34" charset="0"/>
                <a:cs typeface="Arial" panose="020B0604020202020204" pitchFamily="34" charset="0"/>
              </a:rPr>
              <a:t>Live Single Cells</a:t>
            </a:r>
            <a:endParaRPr lang="en-GB" sz="1159" b="1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887A9DF-22D8-E2AE-B5A3-A30216DDB0B6}"/>
              </a:ext>
            </a:extLst>
          </p:cNvPr>
          <p:cNvSpPr txBox="1"/>
          <p:nvPr/>
        </p:nvSpPr>
        <p:spPr>
          <a:xfrm>
            <a:off x="1184476" y="8337719"/>
            <a:ext cx="1168482" cy="254557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GB" sz="948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lang="en-GB" sz="1054">
                <a:latin typeface="Arial" panose="020B0604020202020204" pitchFamily="34" charset="0"/>
                <a:cs typeface="Arial" panose="020B0604020202020204" pitchFamily="34" charset="0"/>
              </a:rPr>
              <a:t> FMO</a:t>
            </a:r>
            <a:endParaRPr lang="en-GB" sz="1054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5A766B0-C01C-2CFE-7277-F27C9C0B3656}"/>
              </a:ext>
            </a:extLst>
          </p:cNvPr>
          <p:cNvSpPr txBox="1"/>
          <p:nvPr/>
        </p:nvSpPr>
        <p:spPr>
          <a:xfrm>
            <a:off x="5886999" y="8341464"/>
            <a:ext cx="1168482" cy="238207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GB" sz="948">
                <a:latin typeface="Arial" panose="020B0604020202020204" pitchFamily="34" charset="0"/>
                <a:cs typeface="Arial" panose="020B0604020202020204" pitchFamily="34" charset="0"/>
              </a:rPr>
              <a:t>ST2 FMO</a:t>
            </a:r>
            <a:endParaRPr lang="en-GB" sz="948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83F3E08-F227-13C9-6FFC-5F860D9C9F97}"/>
              </a:ext>
            </a:extLst>
          </p:cNvPr>
          <p:cNvSpPr/>
          <p:nvPr/>
        </p:nvSpPr>
        <p:spPr>
          <a:xfrm>
            <a:off x="4356656" y="5160797"/>
            <a:ext cx="1127426" cy="1136291"/>
          </a:xfrm>
          <a:custGeom>
            <a:avLst/>
            <a:gdLst>
              <a:gd name="connsiteX0" fmla="*/ 0 w 873755"/>
              <a:gd name="connsiteY0" fmla="*/ 0 h 889208"/>
              <a:gd name="connsiteX1" fmla="*/ 873755 w 873755"/>
              <a:gd name="connsiteY1" fmla="*/ 0 h 889208"/>
              <a:gd name="connsiteX2" fmla="*/ 873755 w 873755"/>
              <a:gd name="connsiteY2" fmla="*/ 889208 h 889208"/>
              <a:gd name="connsiteX3" fmla="*/ 0 w 873755"/>
              <a:gd name="connsiteY3" fmla="*/ 889208 h 889208"/>
              <a:gd name="connsiteX4" fmla="*/ 0 w 873755"/>
              <a:gd name="connsiteY4" fmla="*/ 0 h 889208"/>
              <a:gd name="connsiteX0" fmla="*/ 0 w 873755"/>
              <a:gd name="connsiteY0" fmla="*/ 0 h 889208"/>
              <a:gd name="connsiteX1" fmla="*/ 873755 w 873755"/>
              <a:gd name="connsiteY1" fmla="*/ 0 h 889208"/>
              <a:gd name="connsiteX2" fmla="*/ 873755 w 873755"/>
              <a:gd name="connsiteY2" fmla="*/ 889208 h 889208"/>
              <a:gd name="connsiteX3" fmla="*/ 0 w 873755"/>
              <a:gd name="connsiteY3" fmla="*/ 889208 h 889208"/>
              <a:gd name="connsiteX4" fmla="*/ 237065 w 873755"/>
              <a:gd name="connsiteY4" fmla="*/ 644733 h 889208"/>
              <a:gd name="connsiteX5" fmla="*/ 0 w 873755"/>
              <a:gd name="connsiteY5" fmla="*/ 0 h 889208"/>
              <a:gd name="connsiteX0" fmla="*/ 10585 w 884340"/>
              <a:gd name="connsiteY0" fmla="*/ 0 h 889208"/>
              <a:gd name="connsiteX1" fmla="*/ 884340 w 884340"/>
              <a:gd name="connsiteY1" fmla="*/ 0 h 889208"/>
              <a:gd name="connsiteX2" fmla="*/ 884340 w 884340"/>
              <a:gd name="connsiteY2" fmla="*/ 889208 h 889208"/>
              <a:gd name="connsiteX3" fmla="*/ 10585 w 884340"/>
              <a:gd name="connsiteY3" fmla="*/ 889208 h 889208"/>
              <a:gd name="connsiteX4" fmla="*/ 247650 w 884340"/>
              <a:gd name="connsiteY4" fmla="*/ 644733 h 889208"/>
              <a:gd name="connsiteX5" fmla="*/ 0 w 884340"/>
              <a:gd name="connsiteY5" fmla="*/ 625683 h 889208"/>
              <a:gd name="connsiteX6" fmla="*/ 10585 w 884340"/>
              <a:gd name="connsiteY6" fmla="*/ 0 h 889208"/>
              <a:gd name="connsiteX0" fmla="*/ 10585 w 884340"/>
              <a:gd name="connsiteY0" fmla="*/ 0 h 889208"/>
              <a:gd name="connsiteX1" fmla="*/ 884340 w 884340"/>
              <a:gd name="connsiteY1" fmla="*/ 0 h 889208"/>
              <a:gd name="connsiteX2" fmla="*/ 884340 w 884340"/>
              <a:gd name="connsiteY2" fmla="*/ 889208 h 889208"/>
              <a:gd name="connsiteX3" fmla="*/ 10585 w 884340"/>
              <a:gd name="connsiteY3" fmla="*/ 889208 h 889208"/>
              <a:gd name="connsiteX4" fmla="*/ 247650 w 884340"/>
              <a:gd name="connsiteY4" fmla="*/ 644733 h 889208"/>
              <a:gd name="connsiteX5" fmla="*/ 0 w 884340"/>
              <a:gd name="connsiteY5" fmla="*/ 625683 h 889208"/>
              <a:gd name="connsiteX6" fmla="*/ 10585 w 884340"/>
              <a:gd name="connsiteY6" fmla="*/ 0 h 889208"/>
              <a:gd name="connsiteX0" fmla="*/ 10585 w 884340"/>
              <a:gd name="connsiteY0" fmla="*/ 0 h 889208"/>
              <a:gd name="connsiteX1" fmla="*/ 884340 w 884340"/>
              <a:gd name="connsiteY1" fmla="*/ 0 h 889208"/>
              <a:gd name="connsiteX2" fmla="*/ 884340 w 884340"/>
              <a:gd name="connsiteY2" fmla="*/ 889208 h 889208"/>
              <a:gd name="connsiteX3" fmla="*/ 10585 w 884340"/>
              <a:gd name="connsiteY3" fmla="*/ 889208 h 889208"/>
              <a:gd name="connsiteX4" fmla="*/ 247650 w 884340"/>
              <a:gd name="connsiteY4" fmla="*/ 644733 h 889208"/>
              <a:gd name="connsiteX5" fmla="*/ 0 w 884340"/>
              <a:gd name="connsiteY5" fmla="*/ 638383 h 889208"/>
              <a:gd name="connsiteX6" fmla="*/ 10585 w 884340"/>
              <a:gd name="connsiteY6" fmla="*/ 0 h 889208"/>
              <a:gd name="connsiteX0" fmla="*/ 10585 w 884340"/>
              <a:gd name="connsiteY0" fmla="*/ 0 h 889208"/>
              <a:gd name="connsiteX1" fmla="*/ 884340 w 884340"/>
              <a:gd name="connsiteY1" fmla="*/ 0 h 889208"/>
              <a:gd name="connsiteX2" fmla="*/ 884340 w 884340"/>
              <a:gd name="connsiteY2" fmla="*/ 889208 h 889208"/>
              <a:gd name="connsiteX3" fmla="*/ 10585 w 884340"/>
              <a:gd name="connsiteY3" fmla="*/ 889208 h 889208"/>
              <a:gd name="connsiteX4" fmla="*/ 247650 w 884340"/>
              <a:gd name="connsiteY4" fmla="*/ 644733 h 889208"/>
              <a:gd name="connsiteX5" fmla="*/ 0 w 884340"/>
              <a:gd name="connsiteY5" fmla="*/ 638383 h 889208"/>
              <a:gd name="connsiteX6" fmla="*/ 10585 w 884340"/>
              <a:gd name="connsiteY6" fmla="*/ 0 h 889208"/>
              <a:gd name="connsiteX0" fmla="*/ 10585 w 884340"/>
              <a:gd name="connsiteY0" fmla="*/ 0 h 892383"/>
              <a:gd name="connsiteX1" fmla="*/ 884340 w 884340"/>
              <a:gd name="connsiteY1" fmla="*/ 0 h 892383"/>
              <a:gd name="connsiteX2" fmla="*/ 884340 w 884340"/>
              <a:gd name="connsiteY2" fmla="*/ 889208 h 892383"/>
              <a:gd name="connsiteX3" fmla="*/ 242360 w 884340"/>
              <a:gd name="connsiteY3" fmla="*/ 892383 h 892383"/>
              <a:gd name="connsiteX4" fmla="*/ 247650 w 884340"/>
              <a:gd name="connsiteY4" fmla="*/ 644733 h 892383"/>
              <a:gd name="connsiteX5" fmla="*/ 0 w 884340"/>
              <a:gd name="connsiteY5" fmla="*/ 638383 h 892383"/>
              <a:gd name="connsiteX6" fmla="*/ 10585 w 884340"/>
              <a:gd name="connsiteY6" fmla="*/ 0 h 892383"/>
              <a:gd name="connsiteX0" fmla="*/ 10585 w 884340"/>
              <a:gd name="connsiteY0" fmla="*/ 0 h 892383"/>
              <a:gd name="connsiteX1" fmla="*/ 884340 w 884340"/>
              <a:gd name="connsiteY1" fmla="*/ 0 h 892383"/>
              <a:gd name="connsiteX2" fmla="*/ 884340 w 884340"/>
              <a:gd name="connsiteY2" fmla="*/ 889208 h 892383"/>
              <a:gd name="connsiteX3" fmla="*/ 242360 w 884340"/>
              <a:gd name="connsiteY3" fmla="*/ 892383 h 892383"/>
              <a:gd name="connsiteX4" fmla="*/ 247650 w 884340"/>
              <a:gd name="connsiteY4" fmla="*/ 635208 h 892383"/>
              <a:gd name="connsiteX5" fmla="*/ 0 w 884340"/>
              <a:gd name="connsiteY5" fmla="*/ 638383 h 892383"/>
              <a:gd name="connsiteX6" fmla="*/ 10585 w 884340"/>
              <a:gd name="connsiteY6" fmla="*/ 0 h 892383"/>
              <a:gd name="connsiteX0" fmla="*/ 10585 w 884340"/>
              <a:gd name="connsiteY0" fmla="*/ 0 h 889208"/>
              <a:gd name="connsiteX1" fmla="*/ 884340 w 884340"/>
              <a:gd name="connsiteY1" fmla="*/ 0 h 889208"/>
              <a:gd name="connsiteX2" fmla="*/ 884340 w 884340"/>
              <a:gd name="connsiteY2" fmla="*/ 889208 h 889208"/>
              <a:gd name="connsiteX3" fmla="*/ 251885 w 884340"/>
              <a:gd name="connsiteY3" fmla="*/ 889208 h 889208"/>
              <a:gd name="connsiteX4" fmla="*/ 247650 w 884340"/>
              <a:gd name="connsiteY4" fmla="*/ 635208 h 889208"/>
              <a:gd name="connsiteX5" fmla="*/ 0 w 884340"/>
              <a:gd name="connsiteY5" fmla="*/ 638383 h 889208"/>
              <a:gd name="connsiteX6" fmla="*/ 10585 w 884340"/>
              <a:gd name="connsiteY6" fmla="*/ 0 h 889208"/>
              <a:gd name="connsiteX0" fmla="*/ 0 w 886516"/>
              <a:gd name="connsiteY0" fmla="*/ 0 h 889208"/>
              <a:gd name="connsiteX1" fmla="*/ 886516 w 886516"/>
              <a:gd name="connsiteY1" fmla="*/ 0 h 889208"/>
              <a:gd name="connsiteX2" fmla="*/ 886516 w 886516"/>
              <a:gd name="connsiteY2" fmla="*/ 889208 h 889208"/>
              <a:gd name="connsiteX3" fmla="*/ 254061 w 886516"/>
              <a:gd name="connsiteY3" fmla="*/ 889208 h 889208"/>
              <a:gd name="connsiteX4" fmla="*/ 249826 w 886516"/>
              <a:gd name="connsiteY4" fmla="*/ 635208 h 889208"/>
              <a:gd name="connsiteX5" fmla="*/ 2176 w 886516"/>
              <a:gd name="connsiteY5" fmla="*/ 638383 h 889208"/>
              <a:gd name="connsiteX6" fmla="*/ 0 w 886516"/>
              <a:gd name="connsiteY6" fmla="*/ 0 h 889208"/>
              <a:gd name="connsiteX0" fmla="*/ 0 w 886516"/>
              <a:gd name="connsiteY0" fmla="*/ 0 h 889208"/>
              <a:gd name="connsiteX1" fmla="*/ 886516 w 886516"/>
              <a:gd name="connsiteY1" fmla="*/ 0 h 889208"/>
              <a:gd name="connsiteX2" fmla="*/ 886516 w 886516"/>
              <a:gd name="connsiteY2" fmla="*/ 889208 h 889208"/>
              <a:gd name="connsiteX3" fmla="*/ 238109 w 886516"/>
              <a:gd name="connsiteY3" fmla="*/ 889208 h 889208"/>
              <a:gd name="connsiteX4" fmla="*/ 249826 w 886516"/>
              <a:gd name="connsiteY4" fmla="*/ 635208 h 889208"/>
              <a:gd name="connsiteX5" fmla="*/ 2176 w 886516"/>
              <a:gd name="connsiteY5" fmla="*/ 638383 h 889208"/>
              <a:gd name="connsiteX6" fmla="*/ 0 w 886516"/>
              <a:gd name="connsiteY6" fmla="*/ 0 h 889208"/>
              <a:gd name="connsiteX0" fmla="*/ 0 w 886516"/>
              <a:gd name="connsiteY0" fmla="*/ 0 h 889208"/>
              <a:gd name="connsiteX1" fmla="*/ 886516 w 886516"/>
              <a:gd name="connsiteY1" fmla="*/ 0 h 889208"/>
              <a:gd name="connsiteX2" fmla="*/ 886516 w 886516"/>
              <a:gd name="connsiteY2" fmla="*/ 889208 h 889208"/>
              <a:gd name="connsiteX3" fmla="*/ 238109 w 886516"/>
              <a:gd name="connsiteY3" fmla="*/ 889208 h 889208"/>
              <a:gd name="connsiteX4" fmla="*/ 240255 w 886516"/>
              <a:gd name="connsiteY4" fmla="*/ 635208 h 889208"/>
              <a:gd name="connsiteX5" fmla="*/ 2176 w 886516"/>
              <a:gd name="connsiteY5" fmla="*/ 638383 h 889208"/>
              <a:gd name="connsiteX6" fmla="*/ 0 w 886516"/>
              <a:gd name="connsiteY6" fmla="*/ 0 h 889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86516" h="889208">
                <a:moveTo>
                  <a:pt x="0" y="0"/>
                </a:moveTo>
                <a:lnTo>
                  <a:pt x="886516" y="0"/>
                </a:lnTo>
                <a:lnTo>
                  <a:pt x="886516" y="889208"/>
                </a:lnTo>
                <a:lnTo>
                  <a:pt x="238109" y="889208"/>
                </a:lnTo>
                <a:cubicBezTo>
                  <a:pt x="237756" y="806658"/>
                  <a:pt x="240608" y="717758"/>
                  <a:pt x="240255" y="635208"/>
                </a:cubicBezTo>
                <a:cubicBezTo>
                  <a:pt x="82563" y="633091"/>
                  <a:pt x="83668" y="640500"/>
                  <a:pt x="2176" y="638383"/>
                </a:cubicBezTo>
                <a:cubicBezTo>
                  <a:pt x="1451" y="425589"/>
                  <a:pt x="725" y="212794"/>
                  <a:pt x="0" y="0"/>
                </a:cubicBezTo>
                <a:close/>
              </a:path>
            </a:pathLst>
          </a:cu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4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83B75CE-BD99-A93A-27BD-D98DE0C3CAA4}"/>
              </a:ext>
            </a:extLst>
          </p:cNvPr>
          <p:cNvSpPr txBox="1"/>
          <p:nvPr/>
        </p:nvSpPr>
        <p:spPr>
          <a:xfrm rot="16200000">
            <a:off x="398555" y="5659460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2EC691A-9EAE-2FEB-785C-8061FF93E046}"/>
              </a:ext>
            </a:extLst>
          </p:cNvPr>
          <p:cNvSpPr txBox="1"/>
          <p:nvPr/>
        </p:nvSpPr>
        <p:spPr>
          <a:xfrm rot="16200000">
            <a:off x="395143" y="7346799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3A333E1-4111-5B2A-8F57-9633A847AC6F}"/>
              </a:ext>
            </a:extLst>
          </p:cNvPr>
          <p:cNvSpPr txBox="1"/>
          <p:nvPr/>
        </p:nvSpPr>
        <p:spPr>
          <a:xfrm rot="16200000">
            <a:off x="1969823" y="5659460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 err="1">
                <a:latin typeface="Arial" panose="020B0604020202020204" pitchFamily="34" charset="0"/>
                <a:cs typeface="Arial" panose="020B0604020202020204" pitchFamily="34" charset="0"/>
              </a:rPr>
              <a:t>ckit</a:t>
            </a:r>
            <a:endParaRPr lang="en-GB" sz="84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D5095E0-0376-74D2-95BF-F184D33C563D}"/>
              </a:ext>
            </a:extLst>
          </p:cNvPr>
          <p:cNvSpPr txBox="1"/>
          <p:nvPr/>
        </p:nvSpPr>
        <p:spPr>
          <a:xfrm rot="16200000">
            <a:off x="3541092" y="5659460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el-GR" sz="843" b="1"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896BBCA-F95A-4065-4D6A-F0C796501125}"/>
              </a:ext>
            </a:extLst>
          </p:cNvPr>
          <p:cNvSpPr txBox="1"/>
          <p:nvPr/>
        </p:nvSpPr>
        <p:spPr>
          <a:xfrm rot="16200000">
            <a:off x="5112360" y="5659460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ST2</a:t>
            </a:r>
          </a:p>
        </p:txBody>
      </p:sp>
      <p:sp>
        <p:nvSpPr>
          <p:cNvPr id="36" name="Arc 35">
            <a:extLst>
              <a:ext uri="{FF2B5EF4-FFF2-40B4-BE49-F238E27FC236}">
                <a16:creationId xmlns:a16="http://schemas.microsoft.com/office/drawing/2014/main" id="{AA3524DB-3A68-CF27-5FAF-DD40B082B2D2}"/>
              </a:ext>
            </a:extLst>
          </p:cNvPr>
          <p:cNvSpPr/>
          <p:nvPr/>
        </p:nvSpPr>
        <p:spPr>
          <a:xfrm rot="21214150">
            <a:off x="2139085" y="5548616"/>
            <a:ext cx="893967" cy="404384"/>
          </a:xfrm>
          <a:prstGeom prst="arc">
            <a:avLst>
              <a:gd name="adj1" fmla="val 11272059"/>
              <a:gd name="adj2" fmla="val 21354085"/>
            </a:avLst>
          </a:prstGeom>
          <a:ln w="12700">
            <a:solidFill>
              <a:srgbClr val="C00000"/>
            </a:solidFill>
            <a:tailEnd type="triangle" w="sm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843"/>
          </a:p>
        </p:txBody>
      </p:sp>
      <p:sp>
        <p:nvSpPr>
          <p:cNvPr id="37" name="Arc 36">
            <a:extLst>
              <a:ext uri="{FF2B5EF4-FFF2-40B4-BE49-F238E27FC236}">
                <a16:creationId xmlns:a16="http://schemas.microsoft.com/office/drawing/2014/main" id="{D5FF6B5D-1FAD-A154-CAF1-E985C3D76B06}"/>
              </a:ext>
            </a:extLst>
          </p:cNvPr>
          <p:cNvSpPr/>
          <p:nvPr/>
        </p:nvSpPr>
        <p:spPr>
          <a:xfrm rot="21438456">
            <a:off x="3050397" y="5276442"/>
            <a:ext cx="1465494" cy="404384"/>
          </a:xfrm>
          <a:prstGeom prst="arc">
            <a:avLst>
              <a:gd name="adj1" fmla="val 11023336"/>
              <a:gd name="adj2" fmla="val 21354085"/>
            </a:avLst>
          </a:prstGeom>
          <a:ln w="12700">
            <a:solidFill>
              <a:srgbClr val="C00000"/>
            </a:solidFill>
            <a:tailEnd type="triangle" w="sm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54"/>
          </a:p>
        </p:txBody>
      </p:sp>
      <p:sp>
        <p:nvSpPr>
          <p:cNvPr id="47" name="Arc 46">
            <a:extLst>
              <a:ext uri="{FF2B5EF4-FFF2-40B4-BE49-F238E27FC236}">
                <a16:creationId xmlns:a16="http://schemas.microsoft.com/office/drawing/2014/main" id="{C0A2D8C6-19F6-D07B-3ED7-D91E9D65154B}"/>
              </a:ext>
            </a:extLst>
          </p:cNvPr>
          <p:cNvSpPr/>
          <p:nvPr/>
        </p:nvSpPr>
        <p:spPr>
          <a:xfrm rot="20872296">
            <a:off x="5261090" y="5372587"/>
            <a:ext cx="916818" cy="362052"/>
          </a:xfrm>
          <a:prstGeom prst="arc">
            <a:avLst>
              <a:gd name="adj1" fmla="val 11714015"/>
              <a:gd name="adj2" fmla="val 21354085"/>
            </a:avLst>
          </a:prstGeom>
          <a:ln w="12700">
            <a:solidFill>
              <a:srgbClr val="C00000"/>
            </a:solidFill>
            <a:tailEnd type="triangle" w="sm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54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0DBE9E1-CC84-EEB8-30EA-858E1F265E51}"/>
              </a:ext>
            </a:extLst>
          </p:cNvPr>
          <p:cNvSpPr txBox="1"/>
          <p:nvPr/>
        </p:nvSpPr>
        <p:spPr>
          <a:xfrm rot="16200000">
            <a:off x="1969823" y="7346799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 err="1">
                <a:latin typeface="Arial" panose="020B0604020202020204" pitchFamily="34" charset="0"/>
                <a:cs typeface="Arial" panose="020B0604020202020204" pitchFamily="34" charset="0"/>
              </a:rPr>
              <a:t>ckit</a:t>
            </a:r>
            <a:endParaRPr lang="en-GB" sz="84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8E607E7-2FA7-0680-4F54-B5DD097E9645}"/>
              </a:ext>
            </a:extLst>
          </p:cNvPr>
          <p:cNvSpPr txBox="1"/>
          <p:nvPr/>
        </p:nvSpPr>
        <p:spPr>
          <a:xfrm rot="16200000">
            <a:off x="3541092" y="7346799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el-GR" sz="843" b="1"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37759D3-3674-7BBB-03B5-32E4642C1DF2}"/>
              </a:ext>
            </a:extLst>
          </p:cNvPr>
          <p:cNvSpPr txBox="1"/>
          <p:nvPr/>
        </p:nvSpPr>
        <p:spPr>
          <a:xfrm rot="16200000">
            <a:off x="5112360" y="7346799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b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ST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AF3C0C1-6F29-AFC3-5319-32FAAC3965C6}"/>
              </a:ext>
            </a:extLst>
          </p:cNvPr>
          <p:cNvSpPr txBox="1"/>
          <p:nvPr/>
        </p:nvSpPr>
        <p:spPr>
          <a:xfrm>
            <a:off x="1211511" y="6423868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graphicFrame>
        <p:nvGraphicFramePr>
          <p:cNvPr id="40" name="Table 39">
            <a:extLst>
              <a:ext uri="{FF2B5EF4-FFF2-40B4-BE49-F238E27FC236}">
                <a16:creationId xmlns:a16="http://schemas.microsoft.com/office/drawing/2014/main" id="{BFCEE7AA-2FB7-BABF-A4FE-457FAA6E0B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5875840"/>
              </p:ext>
            </p:extLst>
          </p:nvPr>
        </p:nvGraphicFramePr>
        <p:xfrm>
          <a:off x="4326214" y="8331743"/>
          <a:ext cx="1142085" cy="57282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3837">
                  <a:extLst>
                    <a:ext uri="{9D8B030D-6E8A-4147-A177-3AD203B41FA5}">
                      <a16:colId xmlns:a16="http://schemas.microsoft.com/office/drawing/2014/main" val="2241911292"/>
                    </a:ext>
                  </a:extLst>
                </a:gridCol>
                <a:gridCol w="918248">
                  <a:extLst>
                    <a:ext uri="{9D8B030D-6E8A-4147-A177-3AD203B41FA5}">
                      <a16:colId xmlns:a16="http://schemas.microsoft.com/office/drawing/2014/main" val="4181255076"/>
                    </a:ext>
                  </a:extLst>
                </a:gridCol>
              </a:tblGrid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2D1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E</a:t>
                      </a:r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MO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7139481"/>
                  </a:ext>
                </a:extLst>
              </a:tr>
              <a:tr h="123131"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5237917"/>
                  </a:ext>
                </a:extLst>
              </a:tr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2F2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r>
                        <a:rPr lang="el-GR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ε</a:t>
                      </a:r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 FMO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906963"/>
                  </a:ext>
                </a:extLst>
              </a:tr>
            </a:tbl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6AFAB89E-ACB8-3661-04E7-1E9427528613}"/>
              </a:ext>
            </a:extLst>
          </p:cNvPr>
          <p:cNvSpPr txBox="1"/>
          <p:nvPr/>
        </p:nvSpPr>
        <p:spPr>
          <a:xfrm>
            <a:off x="2789670" y="6423868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C9C7F99-35D3-8625-639F-2522A5F29721}"/>
              </a:ext>
            </a:extLst>
          </p:cNvPr>
          <p:cNvSpPr txBox="1"/>
          <p:nvPr/>
        </p:nvSpPr>
        <p:spPr>
          <a:xfrm>
            <a:off x="4367828" y="6423868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endParaRPr lang="en-GB" sz="84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18ABE32-BB71-84C1-3BF5-58680806B243}"/>
              </a:ext>
            </a:extLst>
          </p:cNvPr>
          <p:cNvSpPr txBox="1"/>
          <p:nvPr/>
        </p:nvSpPr>
        <p:spPr>
          <a:xfrm>
            <a:off x="5945986" y="6423868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graphicFrame>
        <p:nvGraphicFramePr>
          <p:cNvPr id="39" name="Table 38">
            <a:extLst>
              <a:ext uri="{FF2B5EF4-FFF2-40B4-BE49-F238E27FC236}">
                <a16:creationId xmlns:a16="http://schemas.microsoft.com/office/drawing/2014/main" id="{D4EB1C38-8C39-DAE4-844D-1C022E3BED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7196475"/>
              </p:ext>
            </p:extLst>
          </p:nvPr>
        </p:nvGraphicFramePr>
        <p:xfrm>
          <a:off x="2789740" y="8332923"/>
          <a:ext cx="1038560" cy="57282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3837">
                  <a:extLst>
                    <a:ext uri="{9D8B030D-6E8A-4147-A177-3AD203B41FA5}">
                      <a16:colId xmlns:a16="http://schemas.microsoft.com/office/drawing/2014/main" val="2241911292"/>
                    </a:ext>
                  </a:extLst>
                </a:gridCol>
                <a:gridCol w="814723">
                  <a:extLst>
                    <a:ext uri="{9D8B030D-6E8A-4147-A177-3AD203B41FA5}">
                      <a16:colId xmlns:a16="http://schemas.microsoft.com/office/drawing/2014/main" val="4181255076"/>
                    </a:ext>
                  </a:extLst>
                </a:gridCol>
              </a:tblGrid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2D1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it</a:t>
                      </a:r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MO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7139481"/>
                  </a:ext>
                </a:extLst>
              </a:tr>
              <a:tr h="123131"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5237917"/>
                  </a:ext>
                </a:extLst>
              </a:tr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2F2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 FMO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906963"/>
                  </a:ext>
                </a:extLst>
              </a:tr>
            </a:tbl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93AFEB1B-DBFB-3D08-F0AB-6ACE8B2EE48A}"/>
              </a:ext>
            </a:extLst>
          </p:cNvPr>
          <p:cNvSpPr txBox="1"/>
          <p:nvPr/>
        </p:nvSpPr>
        <p:spPr>
          <a:xfrm>
            <a:off x="1181241" y="8170637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474A2B4-82F9-2770-928B-60E5B0DB5073}"/>
              </a:ext>
            </a:extLst>
          </p:cNvPr>
          <p:cNvSpPr txBox="1"/>
          <p:nvPr/>
        </p:nvSpPr>
        <p:spPr>
          <a:xfrm>
            <a:off x="2759399" y="8170637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2D1103A-66E3-57AA-6A6A-6B560A67AB6F}"/>
              </a:ext>
            </a:extLst>
          </p:cNvPr>
          <p:cNvSpPr txBox="1"/>
          <p:nvPr/>
        </p:nvSpPr>
        <p:spPr>
          <a:xfrm>
            <a:off x="4337556" y="8170637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endParaRPr lang="en-GB" sz="84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E6F7D2E-F0F4-E78B-7944-D692C5DF3B5C}"/>
              </a:ext>
            </a:extLst>
          </p:cNvPr>
          <p:cNvSpPr txBox="1"/>
          <p:nvPr/>
        </p:nvSpPr>
        <p:spPr>
          <a:xfrm>
            <a:off x="5915714" y="8170637"/>
            <a:ext cx="1136289" cy="16243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t" anchorCtr="1">
            <a:noAutofit/>
          </a:bodyPr>
          <a:lstStyle/>
          <a:p>
            <a:pPr algn="ctr"/>
            <a:r>
              <a:rPr lang="en-GB" sz="843" b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graphicFrame>
        <p:nvGraphicFramePr>
          <p:cNvPr id="71" name="Table 70">
            <a:extLst>
              <a:ext uri="{FF2B5EF4-FFF2-40B4-BE49-F238E27FC236}">
                <a16:creationId xmlns:a16="http://schemas.microsoft.com/office/drawing/2014/main" id="{5EB7491C-6AB6-46F4-5AFF-6D5CC64E8F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8105434"/>
              </p:ext>
            </p:extLst>
          </p:nvPr>
        </p:nvGraphicFramePr>
        <p:xfrm>
          <a:off x="6027924" y="2443546"/>
          <a:ext cx="1038560" cy="9208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3837">
                  <a:extLst>
                    <a:ext uri="{9D8B030D-6E8A-4147-A177-3AD203B41FA5}">
                      <a16:colId xmlns:a16="http://schemas.microsoft.com/office/drawing/2014/main" val="2241911292"/>
                    </a:ext>
                  </a:extLst>
                </a:gridCol>
                <a:gridCol w="814723">
                  <a:extLst>
                    <a:ext uri="{9D8B030D-6E8A-4147-A177-3AD203B41FA5}">
                      <a16:colId xmlns:a16="http://schemas.microsoft.com/office/drawing/2014/main" val="4181255076"/>
                    </a:ext>
                  </a:extLst>
                </a:gridCol>
              </a:tblGrid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A0A0A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ïve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7139481"/>
                  </a:ext>
                </a:extLst>
              </a:tr>
              <a:tr h="123131"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5237917"/>
                  </a:ext>
                </a:extLst>
              </a:tr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D4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b D7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906963"/>
                  </a:ext>
                </a:extLst>
              </a:tr>
              <a:tr h="123131"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 sz="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76682986"/>
                  </a:ext>
                </a:extLst>
              </a:tr>
              <a:tr h="224849">
                <a:tc>
                  <a:txBody>
                    <a:bodyPr/>
                    <a:lstStyle/>
                    <a:p>
                      <a:endParaRPr lang="en-GB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6364" marR="96364" marT="48182" marB="4818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F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b D28</a:t>
                      </a:r>
                    </a:p>
                  </a:txBody>
                  <a:tcPr marL="96364" marR="9636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07973465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1D12900E-7741-9DC7-E6DC-7943D771ABD6}"/>
              </a:ext>
            </a:extLst>
          </p:cNvPr>
          <p:cNvGrpSpPr/>
          <p:nvPr/>
        </p:nvGrpSpPr>
        <p:grpSpPr>
          <a:xfrm>
            <a:off x="3583283" y="2315572"/>
            <a:ext cx="2321280" cy="2343837"/>
            <a:chOff x="3043520" y="2275008"/>
            <a:chExt cx="2202674" cy="2224079"/>
          </a:xfrm>
        </p:grpSpPr>
        <p:pic>
          <p:nvPicPr>
            <p:cNvPr id="70" name="Picture 69" descr="A screenshot of a computer screen&#10;&#10;AI-generated content may be incorrect.">
              <a:extLst>
                <a:ext uri="{FF2B5EF4-FFF2-40B4-BE49-F238E27FC236}">
                  <a16:creationId xmlns:a16="http://schemas.microsoft.com/office/drawing/2014/main" id="{8BF18C0B-9BD5-0EC1-6629-D6A0224D5D6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2782"/>
            <a:stretch>
              <a:fillRect/>
            </a:stretch>
          </p:blipFill>
          <p:spPr>
            <a:xfrm>
              <a:off x="3043520" y="2275008"/>
              <a:ext cx="2202674" cy="2224079"/>
            </a:xfrm>
            <a:prstGeom prst="rect">
              <a:avLst/>
            </a:prstGeom>
          </p:spPr>
        </p:pic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276691D-069C-4BD0-EABE-09360A4003FE}"/>
                </a:ext>
              </a:extLst>
            </p:cNvPr>
            <p:cNvSpPr txBox="1"/>
            <p:nvPr/>
          </p:nvSpPr>
          <p:spPr>
            <a:xfrm rot="16200000">
              <a:off x="2681779" y="3111651"/>
              <a:ext cx="1078230" cy="1541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 anchor="b" anchorCtr="1">
              <a:noAutofit/>
            </a:bodyPr>
            <a:lstStyle/>
            <a:p>
              <a:pPr algn="ctr"/>
              <a:r>
                <a:rPr lang="en-GB" sz="843" b="1">
                  <a:latin typeface="Arial" panose="020B0604020202020204" pitchFamily="34" charset="0"/>
                  <a:cs typeface="Arial" panose="020B0604020202020204" pitchFamily="34" charset="0"/>
                </a:rPr>
                <a:t>Fc</a:t>
              </a:r>
              <a:r>
                <a:rPr lang="el-GR" sz="843" b="1">
                  <a:latin typeface="Arial" panose="020B0604020202020204" pitchFamily="34" charset="0"/>
                  <a:cs typeface="Arial" panose="020B0604020202020204" pitchFamily="34" charset="0"/>
                </a:rPr>
                <a:t>ε</a:t>
              </a:r>
              <a:r>
                <a:rPr lang="en-GB" sz="843" b="1">
                  <a:latin typeface="Arial" panose="020B0604020202020204" pitchFamily="34" charset="0"/>
                  <a:cs typeface="Arial" panose="020B0604020202020204" pitchFamily="34" charset="0"/>
                </a:rPr>
                <a:t>RI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59C4063-5152-CD5B-D8EE-F5642347C1C0}"/>
                </a:ext>
              </a:extLst>
            </p:cNvPr>
            <p:cNvSpPr txBox="1"/>
            <p:nvPr/>
          </p:nvSpPr>
          <p:spPr>
            <a:xfrm>
              <a:off x="3834392" y="4249806"/>
              <a:ext cx="1078230" cy="1541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 anchor="t" anchorCtr="1">
              <a:noAutofit/>
            </a:bodyPr>
            <a:lstStyle/>
            <a:p>
              <a:pPr algn="ctr"/>
              <a:r>
                <a:rPr lang="en-GB" sz="843" b="1" err="1">
                  <a:latin typeface="Arial" panose="020B0604020202020204" pitchFamily="34" charset="0"/>
                  <a:cs typeface="Arial" panose="020B0604020202020204" pitchFamily="34" charset="0"/>
                </a:rPr>
                <a:t>IgE</a:t>
              </a:r>
              <a:endParaRPr lang="en-GB" sz="843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2790972-6730-0065-D7AA-C38930BE22C4}"/>
              </a:ext>
            </a:extLst>
          </p:cNvPr>
          <p:cNvSpPr txBox="1"/>
          <p:nvPr/>
        </p:nvSpPr>
        <p:spPr>
          <a:xfrm>
            <a:off x="373774" y="108496"/>
            <a:ext cx="342256" cy="319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75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E11BDB-3240-F088-BD1B-010BAB28F924}"/>
              </a:ext>
            </a:extLst>
          </p:cNvPr>
          <p:cNvSpPr txBox="1"/>
          <p:nvPr/>
        </p:nvSpPr>
        <p:spPr>
          <a:xfrm>
            <a:off x="3389281" y="108496"/>
            <a:ext cx="342256" cy="319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75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6A4B96-009C-7A20-BE54-51F8FE487C2D}"/>
              </a:ext>
            </a:extLst>
          </p:cNvPr>
          <p:cNvSpPr txBox="1"/>
          <p:nvPr/>
        </p:nvSpPr>
        <p:spPr>
          <a:xfrm>
            <a:off x="376303" y="2244424"/>
            <a:ext cx="342256" cy="319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75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E6B254-34C1-9024-DDDC-458EC516F935}"/>
              </a:ext>
            </a:extLst>
          </p:cNvPr>
          <p:cNvSpPr txBox="1"/>
          <p:nvPr/>
        </p:nvSpPr>
        <p:spPr>
          <a:xfrm>
            <a:off x="3391810" y="2244424"/>
            <a:ext cx="342256" cy="319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75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D38ACA-013E-A712-2CBC-CBEC0E2B18C3}"/>
              </a:ext>
            </a:extLst>
          </p:cNvPr>
          <p:cNvSpPr txBox="1"/>
          <p:nvPr/>
        </p:nvSpPr>
        <p:spPr>
          <a:xfrm>
            <a:off x="368874" y="4856509"/>
            <a:ext cx="342256" cy="319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75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85BD90E-2C13-ADA3-531D-912E5D4C0C58}"/>
              </a:ext>
            </a:extLst>
          </p:cNvPr>
          <p:cNvSpPr txBox="1"/>
          <p:nvPr/>
        </p:nvSpPr>
        <p:spPr>
          <a:xfrm>
            <a:off x="260945" y="8922294"/>
            <a:ext cx="6821332" cy="15523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4" b="1"/>
              <a:t>Supplementary Figure 1. Flow cytometric detection of </a:t>
            </a:r>
            <a:r>
              <a:rPr lang="en-GB" sz="1054" b="1" err="1"/>
              <a:t>FcεRI</a:t>
            </a:r>
            <a:r>
              <a:rPr lang="en-GB" sz="1054" b="1"/>
              <a:t> changes across </a:t>
            </a:r>
            <a:r>
              <a:rPr lang="en-GB" sz="1054" b="1" err="1"/>
              <a:t>Hpb</a:t>
            </a:r>
            <a:r>
              <a:rPr lang="en-GB" sz="1054" b="1"/>
              <a:t> infection due to IgE-binding.</a:t>
            </a:r>
            <a:r>
              <a:rPr lang="en-GB" sz="1054"/>
              <a:t> </a:t>
            </a:r>
          </a:p>
          <a:p>
            <a:pPr algn="just"/>
            <a:r>
              <a:rPr lang="en-GB" sz="1054"/>
              <a:t>WT C57BL/6J mice were infected with 200 L3 </a:t>
            </a:r>
            <a:r>
              <a:rPr lang="en-GB" sz="1054" i="1" err="1"/>
              <a:t>Hpb</a:t>
            </a:r>
            <a:r>
              <a:rPr lang="en-GB" sz="1054"/>
              <a:t> larvae by oral gavage. Separate cohorts of mice were culled at indicated days of </a:t>
            </a:r>
            <a:r>
              <a:rPr lang="en-GB" sz="1054" i="1" err="1"/>
              <a:t>Hpb</a:t>
            </a:r>
            <a:r>
              <a:rPr lang="en-GB" sz="1054"/>
              <a:t> infection. Peritoneal lavage (PL) was prepared for flow cytometry to assess mast cell </a:t>
            </a:r>
            <a:r>
              <a:rPr lang="en-GB" sz="1054" err="1"/>
              <a:t>FcεRI</a:t>
            </a:r>
            <a:r>
              <a:rPr lang="en-GB" sz="1054"/>
              <a:t> expression (geometric mean fluorescence intensity (</a:t>
            </a:r>
            <a:r>
              <a:rPr lang="en-GB" sz="1054" err="1"/>
              <a:t>gMFI</a:t>
            </a:r>
            <a:r>
              <a:rPr lang="en-GB" sz="1054"/>
              <a:t>) normalised to </a:t>
            </a:r>
            <a:r>
              <a:rPr lang="en-GB" sz="1054" err="1"/>
              <a:t>gMFI</a:t>
            </a:r>
            <a:r>
              <a:rPr lang="en-GB" sz="1054"/>
              <a:t> in naïve mice) (</a:t>
            </a:r>
            <a:r>
              <a:rPr lang="en-GB" sz="1054" b="1"/>
              <a:t>A</a:t>
            </a:r>
            <a:r>
              <a:rPr lang="en-GB" sz="1054"/>
              <a:t>). Serum levels of total IgE (</a:t>
            </a:r>
            <a:r>
              <a:rPr lang="en-GB" sz="1054" b="1"/>
              <a:t>B</a:t>
            </a:r>
            <a:r>
              <a:rPr lang="en-GB" sz="1054"/>
              <a:t>) were also measured which showed a negative correlation with mast cell </a:t>
            </a:r>
            <a:r>
              <a:rPr lang="en-GB" sz="1054" err="1"/>
              <a:t>FcεRI</a:t>
            </a:r>
            <a:r>
              <a:rPr lang="en-GB" sz="1054"/>
              <a:t> </a:t>
            </a:r>
            <a:r>
              <a:rPr lang="en-GB" sz="1054" err="1"/>
              <a:t>gMFI</a:t>
            </a:r>
            <a:r>
              <a:rPr lang="en-GB" sz="1054"/>
              <a:t> (</a:t>
            </a:r>
            <a:r>
              <a:rPr lang="en-GB" sz="1054" b="1"/>
              <a:t>C</a:t>
            </a:r>
            <a:r>
              <a:rPr lang="en-GB" sz="1054"/>
              <a:t>). Data in (</a:t>
            </a:r>
            <a:r>
              <a:rPr lang="en-GB" sz="1054" b="1"/>
              <a:t>A-C</a:t>
            </a:r>
            <a:r>
              <a:rPr lang="en-GB" sz="1054"/>
              <a:t>) is representative of 2 experiments, each with n=6/group. Mice were 8-12 weeks old, with only male WT C57BL/6J mice used. Error bars show mean ± SEM. Flow cytometric analysis of PL mast cells also showed a negative correlation between detection of surface </a:t>
            </a:r>
            <a:r>
              <a:rPr lang="en-GB" sz="1054" err="1"/>
              <a:t>FcεRI</a:t>
            </a:r>
            <a:r>
              <a:rPr lang="en-GB" sz="1054"/>
              <a:t> and IgE, with representative samples in naïve, </a:t>
            </a:r>
            <a:r>
              <a:rPr lang="en-GB" sz="1054" i="1" err="1"/>
              <a:t>Hpb</a:t>
            </a:r>
            <a:r>
              <a:rPr lang="en-GB" sz="1054"/>
              <a:t> D7 and </a:t>
            </a:r>
            <a:r>
              <a:rPr lang="en-GB" sz="1054" i="1" err="1"/>
              <a:t>Hpb</a:t>
            </a:r>
            <a:r>
              <a:rPr lang="en-GB" sz="1054"/>
              <a:t> D28 mice shown (</a:t>
            </a:r>
            <a:r>
              <a:rPr lang="en-GB" sz="1054" b="1"/>
              <a:t>D</a:t>
            </a:r>
            <a:r>
              <a:rPr lang="en-GB" sz="1054"/>
              <a:t>). As such, gating strategy of mast cells was updated to include IgE+ cells (</a:t>
            </a:r>
            <a:r>
              <a:rPr lang="en-GB" sz="1054" b="1"/>
              <a:t>E</a:t>
            </a:r>
            <a:r>
              <a:rPr lang="en-GB" sz="1054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524332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C1281A6A-10D5-49AB-ADA3-4394259D06B6}">
  <we:reference id="WA200006038" version="1.0.0.5" store="Omex" storeType="OMEX"/>
  <we:alternateReferences>
    <we:reference id="WA200006038" version="1.0.0.5" store="WA200006038" storeType="OMEX"/>
  </we:alternateReferences>
  <we:properties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1</Words>
  <Application>Microsoft Macintosh PowerPoint</Application>
  <PresentationFormat>Custom</PresentationFormat>
  <Paragraphs>3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ole Ong (Staff)</dc:creator>
  <cp:lastModifiedBy>Henry McSorley (Staff)</cp:lastModifiedBy>
  <cp:revision>2</cp:revision>
  <dcterms:created xsi:type="dcterms:W3CDTF">2025-08-07T09:20:26Z</dcterms:created>
  <dcterms:modified xsi:type="dcterms:W3CDTF">2026-03-18T11:29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618d1e0-f5d7-4da7-8ddd-3b83021a2c85_Enabled">
    <vt:lpwstr>true</vt:lpwstr>
  </property>
  <property fmtid="{D5CDD505-2E9C-101B-9397-08002B2CF9AE}" pid="3" name="MSIP_Label_a618d1e0-f5d7-4da7-8ddd-3b83021a2c85_SetDate">
    <vt:lpwstr>2025-08-07T09:38:30Z</vt:lpwstr>
  </property>
  <property fmtid="{D5CDD505-2E9C-101B-9397-08002B2CF9AE}" pid="4" name="MSIP_Label_a618d1e0-f5d7-4da7-8ddd-3b83021a2c85_Method">
    <vt:lpwstr>Standard</vt:lpwstr>
  </property>
  <property fmtid="{D5CDD505-2E9C-101B-9397-08002B2CF9AE}" pid="5" name="MSIP_Label_a618d1e0-f5d7-4da7-8ddd-3b83021a2c85_Name">
    <vt:lpwstr>Private</vt:lpwstr>
  </property>
  <property fmtid="{D5CDD505-2E9C-101B-9397-08002B2CF9AE}" pid="6" name="MSIP_Label_a618d1e0-f5d7-4da7-8ddd-3b83021a2c85_SiteId">
    <vt:lpwstr>ae323139-093a-4d2a-81a6-5d334bcd9019</vt:lpwstr>
  </property>
  <property fmtid="{D5CDD505-2E9C-101B-9397-08002B2CF9AE}" pid="7" name="MSIP_Label_a618d1e0-f5d7-4da7-8ddd-3b83021a2c85_ActionId">
    <vt:lpwstr>00769066-d801-4ffe-a0fe-27bcbe87236e</vt:lpwstr>
  </property>
  <property fmtid="{D5CDD505-2E9C-101B-9397-08002B2CF9AE}" pid="8" name="MSIP_Label_a618d1e0-f5d7-4da7-8ddd-3b83021a2c85_ContentBits">
    <vt:lpwstr>0</vt:lpwstr>
  </property>
  <property fmtid="{D5CDD505-2E9C-101B-9397-08002B2CF9AE}" pid="9" name="MSIP_Label_a618d1e0-f5d7-4da7-8ddd-3b83021a2c85_Tag">
    <vt:lpwstr>10, 3, 0, 1</vt:lpwstr>
  </property>
</Properties>
</file>